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4" r:id="rId2"/>
    <p:sldId id="261" r:id="rId3"/>
    <p:sldId id="262" r:id="rId4"/>
    <p:sldId id="263" r:id="rId5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80" d="100"/>
          <a:sy n="80" d="100"/>
        </p:scale>
        <p:origin x="120" y="80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9EE3CA2E-B3DF-4BDA-A132-618000C37CD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D66F4452-C09D-4416-928D-70E0F1DCF09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3A70A99C-A501-451C-9420-7576D011E0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A46E12-43AB-46A1-B74A-E649BFBFBA43}" type="datetimeFigureOut">
              <a:rPr lang="ko-KR" altLang="en-US" smtClean="0"/>
              <a:t>2025-01-26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57A2EFA8-3EA8-42F2-9EAE-52FA5F7C8B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A1F8ED20-AC3F-48FA-89DE-9F15042FC3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174511-A60F-47E5-A221-21A054B5B82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971159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251E5892-AFCE-4CA5-A36B-88ABFA6CEF6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7D5D167D-3BF7-4D35-B599-B59B8E4F6FF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4E25E54A-5CB1-49E5-928F-F8E76340DF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A46E12-43AB-46A1-B74A-E649BFBFBA43}" type="datetimeFigureOut">
              <a:rPr lang="ko-KR" altLang="en-US" smtClean="0"/>
              <a:t>2025-01-26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08DA9FC6-89E0-40C2-8338-F3F09F00B0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228394BC-4591-4BE5-9030-4A42D24523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174511-A60F-47E5-A221-21A054B5B82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586039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799C9BA6-C454-4E3C-B0A8-D2E50D56C31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B295751A-FDF1-4364-8153-9512A4A6404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5B96AF2D-F90E-40C6-B917-5C925D83C0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A46E12-43AB-46A1-B74A-E649BFBFBA43}" type="datetimeFigureOut">
              <a:rPr lang="ko-KR" altLang="en-US" smtClean="0"/>
              <a:t>2025-01-26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2F116300-54E7-4F8B-8783-DD8EDA2268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E36297E6-1FB2-4921-9819-9C06E06F76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174511-A60F-47E5-A221-21A054B5B82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556167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2492019D-2458-4921-B191-BBE595013E7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7C21FDEB-FD2F-4775-BB13-CF4F994709C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04BDB25F-3793-412D-9AF8-64799BD721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A46E12-43AB-46A1-B74A-E649BFBFBA43}" type="datetimeFigureOut">
              <a:rPr lang="ko-KR" altLang="en-US" smtClean="0"/>
              <a:t>2025-01-26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12B70539-B615-4BED-AEF4-D2A70883A9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CFB3D984-6D18-4655-A3ED-6FCB1C4791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174511-A60F-47E5-A221-21A054B5B82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235216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F53A06F2-35AE-4AB6-A3B5-18ED1E85D5C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8722BE4A-E94A-4A10-A87F-9DBE1A0D572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7C7C9DDD-113F-4CA4-852C-333DEBB529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A46E12-43AB-46A1-B74A-E649BFBFBA43}" type="datetimeFigureOut">
              <a:rPr lang="ko-KR" altLang="en-US" smtClean="0"/>
              <a:t>2025-01-26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E0F7AA0A-7908-433C-ADCB-9A6AC6D916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148DFBFA-55BB-4E79-BE41-F2B11FB467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174511-A60F-47E5-A221-21A054B5B82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333642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F969F5F5-D2B0-4443-95D9-2F2DEA74402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C09DB979-C30C-43D3-813F-0D08C990965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F4ECD18C-AABF-4AF6-88A3-E12143558C8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8DBE8A1D-0322-4126-B713-24A978A2DD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A46E12-43AB-46A1-B74A-E649BFBFBA43}" type="datetimeFigureOut">
              <a:rPr lang="ko-KR" altLang="en-US" smtClean="0"/>
              <a:t>2025-01-26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A9A408BD-64D3-41B6-B232-CA8FFCB682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B5793ABB-DE41-4D6D-A030-C6B96E6036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174511-A60F-47E5-A221-21A054B5B82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133020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288188A2-4B64-468D-BC3C-C2F5E89B0AF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9A83CA39-A96B-414F-AC9A-3B931ACBD6A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E9A807A1-47C8-4DFA-9A10-BA7EF64F2A4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3CB9D8B6-4224-483B-BE6A-2DB18A94E3C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383DA074-E34A-4FCF-9BC4-9CB00A3DE51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BD92E040-2A67-41FD-ADF8-519BF2EC6A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A46E12-43AB-46A1-B74A-E649BFBFBA43}" type="datetimeFigureOut">
              <a:rPr lang="ko-KR" altLang="en-US" smtClean="0"/>
              <a:t>2025-01-26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8B34D4A6-B6C0-4990-8DFB-5771C3537D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AD7FCF00-5A96-41F1-ACAD-66FA54BEAA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174511-A60F-47E5-A221-21A054B5B82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046168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F57C5B5B-45ED-42CC-A69A-0DE82C82F1B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64F205D6-3AC4-4A46-9646-55AA7A0FCB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A46E12-43AB-46A1-B74A-E649BFBFBA43}" type="datetimeFigureOut">
              <a:rPr lang="ko-KR" altLang="en-US" smtClean="0"/>
              <a:t>2025-01-26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AB5D0615-72BA-4EE2-9F33-1C16F94469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D5689138-D389-4EB3-A223-C013E5C3B5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174511-A60F-47E5-A221-21A054B5B82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884776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B32CE80F-E40E-4485-82F5-C8929B96AC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A46E12-43AB-46A1-B74A-E649BFBFBA43}" type="datetimeFigureOut">
              <a:rPr lang="ko-KR" altLang="en-US" smtClean="0"/>
              <a:t>2025-01-26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40F7624E-E350-427A-A9DB-36DD55A2EB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30B40EC4-F4F7-46D8-BFC6-93F95BBCF0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174511-A60F-47E5-A221-21A054B5B82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807275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19EB7B6D-F2A6-4FB0-8BFC-006868D950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638ABEAF-2DA5-45C6-A95E-9C5AE5C3CA3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CFD85784-945D-48B7-B3FC-F4EFE8EB428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727EC5A5-F88C-4329-ADD4-C9F54AE2FE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A46E12-43AB-46A1-B74A-E649BFBFBA43}" type="datetimeFigureOut">
              <a:rPr lang="ko-KR" altLang="en-US" smtClean="0"/>
              <a:t>2025-01-26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82986623-A06C-4307-B58A-40DE2EC6B4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C19D696A-A046-470B-B438-E832C82D79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174511-A60F-47E5-A221-21A054B5B82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611116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C47DA0CE-6437-43C5-A60C-1A5F60F8559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ADE4CDE7-7335-4C61-AA7A-6CAD464BCD4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2E77EF3B-5A38-45CF-96CA-95D15C37E77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2BA749BC-2972-4B0D-9819-FEE6916ACF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A46E12-43AB-46A1-B74A-E649BFBFBA43}" type="datetimeFigureOut">
              <a:rPr lang="ko-KR" altLang="en-US" smtClean="0"/>
              <a:t>2025-01-26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A9E8378A-C449-4219-9EEB-666D79024C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AA002617-3332-4A15-9EF4-49C67C2436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174511-A60F-47E5-A221-21A054B5B82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084658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97DC9A70-32E3-472A-9C56-C46A849B542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4965C090-1CB8-4733-8433-3ECB9C68BB9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7883B93F-6857-4BBE-B5FC-5F94AF7EF08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A46E12-43AB-46A1-B74A-E649BFBFBA43}" type="datetimeFigureOut">
              <a:rPr lang="ko-KR" altLang="en-US" smtClean="0"/>
              <a:t>2025-01-26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4222B55F-A452-4EC5-B156-7BC497703E0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2AD84860-00DE-4B47-8000-4D725BCB327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174511-A60F-47E5-A221-21A054B5B82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454613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직사각형 3">
            <a:extLst>
              <a:ext uri="{FF2B5EF4-FFF2-40B4-BE49-F238E27FC236}">
                <a16:creationId xmlns:a16="http://schemas.microsoft.com/office/drawing/2014/main" id="{AE669393-262C-45DC-845D-813EA66FD815}"/>
              </a:ext>
            </a:extLst>
          </p:cNvPr>
          <p:cNvSpPr/>
          <p:nvPr/>
        </p:nvSpPr>
        <p:spPr>
          <a:xfrm>
            <a:off x="557462" y="416544"/>
            <a:ext cx="10006263" cy="547752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 latinLnBrk="0">
              <a:lnSpc>
                <a:spcPct val="107000"/>
              </a:lnSpc>
              <a:spcAft>
                <a:spcPts val="800"/>
              </a:spcAft>
            </a:pPr>
            <a:r>
              <a:rPr lang="en-US" altLang="ko-KR" sz="160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Legends</a:t>
            </a:r>
            <a:endParaRPr lang="ko-KR" altLang="ko-KR" sz="1100" kern="100" dirty="0">
              <a:latin typeface="맑은 고딕" panose="020B0503020000020004" pitchFamily="50" charset="-127"/>
              <a:cs typeface="Times New Roman" panose="02020603050405020304" pitchFamily="18" charset="0"/>
            </a:endParaRPr>
          </a:p>
          <a:p>
            <a:pPr algn="just" latinLnBrk="0">
              <a:lnSpc>
                <a:spcPct val="107000"/>
              </a:lnSpc>
              <a:spcAft>
                <a:spcPts val="800"/>
              </a:spcAft>
            </a:pPr>
            <a:r>
              <a:rPr lang="en-US" altLang="ko-KR" sz="160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endParaRPr lang="ko-KR" altLang="ko-KR" sz="1100" kern="100" dirty="0">
              <a:latin typeface="맑은 고딕" panose="020B0503020000020004" pitchFamily="50" charset="-127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  <a:spcAft>
                <a:spcPts val="800"/>
              </a:spcAft>
            </a:pPr>
            <a:r>
              <a:rPr lang="en-US" altLang="ko-KR" sz="1400" b="1" kern="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. Illustration of the population pharmacokinetic model of cyclophosphamide and its metabolite.</a:t>
            </a:r>
            <a:endParaRPr lang="ko-KR" altLang="ko-KR" sz="1100" kern="100" dirty="0">
              <a:latin typeface="맑은 고딕" panose="020B0503020000020004" pitchFamily="50" charset="-127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  <a:spcAft>
                <a:spcPts val="800"/>
              </a:spcAft>
            </a:pPr>
            <a:r>
              <a:rPr lang="en-US" altLang="ko-KR" sz="1400" kern="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yclophosphamide is metabolized to HCY, which is then metabolized to CEPM. An enzyme compartment was used to explain the auto-induction of cyclophosphamide metabolism. The inducible clearance (CL</a:t>
            </a:r>
            <a:r>
              <a:rPr lang="en-US" altLang="ko-KR" sz="1400" kern="0" baseline="-25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ND</a:t>
            </a:r>
            <a:r>
              <a:rPr lang="en-US" altLang="ko-KR" sz="1400" kern="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 depends on the concentration of cyclophosphamide (C</a:t>
            </a:r>
            <a:r>
              <a:rPr lang="en-US" altLang="ko-KR" sz="1400" kern="0" baseline="-25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Y</a:t>
            </a:r>
            <a:r>
              <a:rPr lang="en-US" altLang="ko-KR" sz="1400" kern="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ko-KR" altLang="ko-KR" sz="1100" kern="100" dirty="0">
              <a:latin typeface="맑은 고딕" panose="020B0503020000020004" pitchFamily="50" charset="-127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  <a:spcAft>
                <a:spcPts val="800"/>
              </a:spcAft>
            </a:pPr>
            <a:r>
              <a:rPr lang="en-US" altLang="ko-KR" sz="1400" b="1" kern="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. Goodness-of-fit plots and visual predictive checks for the final pharmacokinetic model of cyclophosphamide</a:t>
            </a:r>
            <a:endParaRPr lang="ko-KR" altLang="ko-KR" sz="1100" kern="100" dirty="0">
              <a:latin typeface="맑은 고딕" panose="020B0503020000020004" pitchFamily="50" charset="-127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  <a:spcAft>
                <a:spcPts val="800"/>
              </a:spcAft>
            </a:pPr>
            <a:r>
              <a:rPr lang="en-US" altLang="ko-KR" sz="1400" kern="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A) Goodness-of-fit plots: Open circles indicate observations; solid black lines are identity lines. (B) Visual predictive checks: Circles represent observed concentrations; solid lines represent the 5th (blue), median (red), and 95th (blue) concentration percentiles; blue and red areas indicate the 90% confidence interval of the simulated concentrations of each percentile.</a:t>
            </a:r>
            <a:endParaRPr lang="ko-KR" altLang="ko-KR" sz="1100" kern="100" dirty="0">
              <a:latin typeface="맑은 고딕" panose="020B0503020000020004" pitchFamily="50" charset="-127"/>
              <a:cs typeface="Times New Roman" panose="02020603050405020304" pitchFamily="18" charset="0"/>
            </a:endParaRPr>
          </a:p>
          <a:p>
            <a:pPr algn="just" latinLnBrk="0">
              <a:lnSpc>
                <a:spcPct val="200000"/>
              </a:lnSpc>
              <a:spcAft>
                <a:spcPts val="800"/>
              </a:spcAft>
            </a:pPr>
            <a:r>
              <a:rPr lang="en-US" altLang="ko-KR" sz="1400" b="1" kern="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3. Weight distribution of pediatric patients undergoing myeloablative conditioning regimen in Seoul National University Children’s Hospital from 2009 to 2020.</a:t>
            </a:r>
            <a:endParaRPr lang="ko-KR" altLang="ko-KR" sz="1100" kern="100" dirty="0">
              <a:latin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4804494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C6E1F547-F831-4A83-85B2-FE967C1EC4DB}"/>
              </a:ext>
            </a:extLst>
          </p:cNvPr>
          <p:cNvSpPr txBox="1"/>
          <p:nvPr/>
        </p:nvSpPr>
        <p:spPr>
          <a:xfrm>
            <a:off x="318781" y="302004"/>
            <a:ext cx="310533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  <a:endParaRPr lang="ko-KR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Picture 1">
            <a:extLst>
              <a:ext uri="{FF2B5EF4-FFF2-40B4-BE49-F238E27FC236}">
                <a16:creationId xmlns:a16="http://schemas.microsoft.com/office/drawing/2014/main" id="{AE3F2C0A-5813-4BED-86E5-13347CFDBBBA}"/>
              </a:ext>
            </a:extLst>
          </p:cNvPr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96395" y="637216"/>
            <a:ext cx="8254284" cy="52183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4188607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C6E1F547-F831-4A83-85B2-FE967C1EC4DB}"/>
              </a:ext>
            </a:extLst>
          </p:cNvPr>
          <p:cNvSpPr txBox="1"/>
          <p:nvPr/>
        </p:nvSpPr>
        <p:spPr>
          <a:xfrm>
            <a:off x="318781" y="302004"/>
            <a:ext cx="310533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</a:t>
            </a:r>
            <a:endParaRPr lang="ko-KR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Picture 5">
            <a:extLst>
              <a:ext uri="{FF2B5EF4-FFF2-40B4-BE49-F238E27FC236}">
                <a16:creationId xmlns:a16="http://schemas.microsoft.com/office/drawing/2014/main" id="{5D742865-D1CA-410D-88F9-EFC6D1F18D61}"/>
              </a:ext>
            </a:extLst>
          </p:cNvPr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8259" y="840996"/>
            <a:ext cx="11092772" cy="5715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7130386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C6E1F547-F831-4A83-85B2-FE967C1EC4DB}"/>
              </a:ext>
            </a:extLst>
          </p:cNvPr>
          <p:cNvSpPr txBox="1"/>
          <p:nvPr/>
        </p:nvSpPr>
        <p:spPr>
          <a:xfrm>
            <a:off x="318781" y="302004"/>
            <a:ext cx="310533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3</a:t>
            </a:r>
            <a:endParaRPr lang="ko-KR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Picture 11">
            <a:extLst>
              <a:ext uri="{FF2B5EF4-FFF2-40B4-BE49-F238E27FC236}">
                <a16:creationId xmlns:a16="http://schemas.microsoft.com/office/drawing/2014/main" id="{7FA67ECF-3779-402E-A99F-839175264DFB}"/>
              </a:ext>
            </a:extLst>
          </p:cNvPr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61504" y="992714"/>
            <a:ext cx="8908624" cy="54919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720895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179</Words>
  <Application>Microsoft Office PowerPoint</Application>
  <PresentationFormat>와이드스크린</PresentationFormat>
  <Paragraphs>10</Paragraphs>
  <Slides>4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4</vt:i4>
      </vt:variant>
    </vt:vector>
  </HeadingPairs>
  <TitlesOfParts>
    <vt:vector size="8" baseType="lpstr">
      <vt:lpstr>맑은 고딕</vt:lpstr>
      <vt:lpstr>Arial</vt:lpstr>
      <vt:lpstr>Times New Roman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KTH</dc:creator>
  <cp:lastModifiedBy>Windows 사용자</cp:lastModifiedBy>
  <cp:revision>3</cp:revision>
  <dcterms:created xsi:type="dcterms:W3CDTF">2024-07-08T21:33:16Z</dcterms:created>
  <dcterms:modified xsi:type="dcterms:W3CDTF">2025-01-26T13:43:27Z</dcterms:modified>
</cp:coreProperties>
</file>